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oth, Christian" initials="RC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888" autoAdjust="0"/>
  </p:normalViewPr>
  <p:slideViewPr>
    <p:cSldViewPr>
      <p:cViewPr>
        <p:scale>
          <a:sx n="90" d="100"/>
          <a:sy n="90" d="100"/>
        </p:scale>
        <p:origin x="-1572" y="-4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0398C95-0F0D-472D-B917-75B7F0277D03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6DBC7CA-ECE9-43BC-82DC-757F21AE99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404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817540A-AF51-4C18-B95E-CDADE8B2AFD4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D1211A1-A1F7-476E-B2CF-E51573E43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516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elationships between OGTT-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UC</a:t>
            </a:r>
            <a:r>
              <a:rPr lang="en-US" sz="1200" b="0" i="0" u="none" strike="noStrike" kern="1200" baseline="-250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lucose</a:t>
            </a:r>
            <a:r>
              <a:rPr lang="en-US" sz="1200" b="0" i="0" u="none" strike="noStrike" kern="1200" baseline="-250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0-120 min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rouped in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ertiles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d different glucose metabolism parameters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1211A1-A1F7-476E-B2CF-E51573E43B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3342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178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450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765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879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922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43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942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315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983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58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033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60E57-9574-45FD-843D-DCB83B22213A}" type="datetimeFigureOut">
              <a:rPr lang="en-US" smtClean="0"/>
              <a:t>5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2E5CC-4074-4F91-BC65-F759E29E64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511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0" y="-76200"/>
            <a:ext cx="1105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1 S</a:t>
            </a:r>
            <a:endParaRPr lang="en-US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-116795" y="946666"/>
            <a:ext cx="9664551" cy="4844534"/>
            <a:chOff x="-116795" y="184666"/>
            <a:chExt cx="9664551" cy="4844534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29400" y="239449"/>
              <a:ext cx="2918356" cy="2427551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9600" y="2669719"/>
              <a:ext cx="2842448" cy="235948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5597" y="331260"/>
              <a:ext cx="2701203" cy="232964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16795" y="2691607"/>
              <a:ext cx="2783795" cy="2337593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9302" y="321432"/>
              <a:ext cx="2891319" cy="2339101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15140" y="184666"/>
              <a:ext cx="2806982" cy="2481696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17787" y="2690099"/>
              <a:ext cx="2859013" cy="2339101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25874" y="2680823"/>
              <a:ext cx="2722926" cy="2348377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52448" y="21693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A</a:t>
              </a:r>
              <a:endParaRPr 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36460" y="228600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B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470060" y="24026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</a:t>
              </a:r>
              <a:endParaRPr lang="en-US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679860" y="240268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</a:t>
              </a:r>
              <a:endParaRPr lang="en-US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0" y="2579132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E</a:t>
              </a:r>
              <a:endParaRPr lang="en-US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84012" y="2590800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F</a:t>
              </a:r>
              <a:endParaRPr lang="en-US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544658" y="2602468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G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832260" y="2602468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H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214512" y="5562600"/>
            <a:ext cx="892948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r>
              <a:rPr lang="en-US" b="1" i="1" dirty="0"/>
              <a:t>Supplemental Figure 1:</a:t>
            </a:r>
            <a:r>
              <a:rPr lang="en-US" b="1" dirty="0"/>
              <a:t> </a:t>
            </a:r>
          </a:p>
          <a:p>
            <a:r>
              <a:rPr lang="en-US" dirty="0"/>
              <a:t>Relationships between OGTT-AUC</a:t>
            </a:r>
            <a:r>
              <a:rPr lang="en-US" baseline="-25000" dirty="0"/>
              <a:t>Gluc0-120 </a:t>
            </a:r>
            <a:r>
              <a:rPr lang="en-US" dirty="0"/>
              <a:t>grouped in </a:t>
            </a:r>
            <a:r>
              <a:rPr lang="en-US" dirty="0" err="1"/>
              <a:t>tertiles</a:t>
            </a:r>
            <a:r>
              <a:rPr lang="en-US" dirty="0"/>
              <a:t> and different glucose metabolism parameters. Analysis by </a:t>
            </a:r>
            <a:r>
              <a:rPr lang="en-US" dirty="0" err="1"/>
              <a:t>Kruskal</a:t>
            </a:r>
            <a:r>
              <a:rPr lang="en-US" dirty="0"/>
              <a:t>-Wallis test followed by Dunn’s post test. Test. *** P &lt; 0.001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1722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80</TotalTime>
  <Words>59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eattle Children'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fers, Clinton</dc:creator>
  <cp:lastModifiedBy>croth1</cp:lastModifiedBy>
  <cp:revision>133</cp:revision>
  <cp:lastPrinted>2017-05-01T18:03:35Z</cp:lastPrinted>
  <dcterms:created xsi:type="dcterms:W3CDTF">2017-03-27T21:20:19Z</dcterms:created>
  <dcterms:modified xsi:type="dcterms:W3CDTF">2017-05-18T22:23:27Z</dcterms:modified>
</cp:coreProperties>
</file>